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31"/>
    <p:restoredTop sz="94682"/>
  </p:normalViewPr>
  <p:slideViewPr>
    <p:cSldViewPr snapToGrid="0">
      <p:cViewPr>
        <p:scale>
          <a:sx n="261" d="100"/>
          <a:sy n="261" d="100"/>
        </p:scale>
        <p:origin x="-504" y="-4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kae/Downloads/tsunoi_data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BSA-1</c:v>
          </c:tx>
          <c:spPr>
            <a:ln w="6350">
              <a:solidFill>
                <a:schemeClr val="accent2"/>
              </a:solidFill>
            </a:ln>
          </c:spPr>
          <c:marker>
            <c:symbol val="none"/>
          </c:marker>
          <c:yVal>
            <c:numRef>
              <c:f>Sheet1!$Q$9:$Q$47</c:f>
              <c:numCache>
                <c:formatCode>General</c:formatCode>
                <c:ptCount val="39"/>
                <c:pt idx="0">
                  <c:v>3.2840378116816282E-3</c:v>
                </c:pt>
                <c:pt idx="1">
                  <c:v>2.7391663752496243E-3</c:v>
                </c:pt>
                <c:pt idx="2">
                  <c:v>2.05213762819767E-3</c:v>
                </c:pt>
                <c:pt idx="3">
                  <c:v>1.3182598631829023E-3</c:v>
                </c:pt>
                <c:pt idx="4">
                  <c:v>1.0580600937828422E-3</c:v>
                </c:pt>
                <c:pt idx="5">
                  <c:v>4.9122428754344583E-4</c:v>
                </c:pt>
                <c:pt idx="6">
                  <c:v>1.6522103396710008E-4</c:v>
                </c:pt>
                <c:pt idx="7">
                  <c:v>2.5094854208873585E-5</c:v>
                </c:pt>
                <c:pt idx="8">
                  <c:v>-3.7577183684334159E-4</c:v>
                </c:pt>
                <c:pt idx="9">
                  <c:v>-6.0625863261520863E-4</c:v>
                </c:pt>
                <c:pt idx="10">
                  <c:v>-6.7667721305042505E-4</c:v>
                </c:pt>
                <c:pt idx="11">
                  <c:v>-1.0135284392163157E-3</c:v>
                </c:pt>
                <c:pt idx="12">
                  <c:v>-1.1789866257458925E-3</c:v>
                </c:pt>
                <c:pt idx="13">
                  <c:v>-1.6280735144391656E-3</c:v>
                </c:pt>
                <c:pt idx="14">
                  <c:v>-1.351175713352859E-3</c:v>
                </c:pt>
                <c:pt idx="15">
                  <c:v>-1.7437275964766741E-3</c:v>
                </c:pt>
                <c:pt idx="16">
                  <c:v>-1.7479254165664315E-3</c:v>
                </c:pt>
                <c:pt idx="17">
                  <c:v>-1.7031579045578837E-3</c:v>
                </c:pt>
                <c:pt idx="18">
                  <c:v>-1.1938915122300386E-3</c:v>
                </c:pt>
                <c:pt idx="19">
                  <c:v>-3.787340538110584E-4</c:v>
                </c:pt>
                <c:pt idx="20">
                  <c:v>1.7907900037243962E-3</c:v>
                </c:pt>
                <c:pt idx="21">
                  <c:v>6.6971206106245518E-3</c:v>
                </c:pt>
                <c:pt idx="22">
                  <c:v>1.5250748954713345E-2</c:v>
                </c:pt>
                <c:pt idx="23">
                  <c:v>3.1986188143491745E-2</c:v>
                </c:pt>
                <c:pt idx="24">
                  <c:v>6.5163657069206238E-2</c:v>
                </c:pt>
                <c:pt idx="25">
                  <c:v>0.12886349856853485</c:v>
                </c:pt>
                <c:pt idx="26">
                  <c:v>0.24122408032417297</c:v>
                </c:pt>
                <c:pt idx="27">
                  <c:v>0.40920251607894897</c:v>
                </c:pt>
                <c:pt idx="28">
                  <c:v>0.6138419508934021</c:v>
                </c:pt>
                <c:pt idx="29">
                  <c:v>0.82611286640167236</c:v>
                </c:pt>
                <c:pt idx="30">
                  <c:v>1.0280885696411133</c:v>
                </c:pt>
                <c:pt idx="31">
                  <c:v>1.2111895084381104</c:v>
                </c:pt>
                <c:pt idx="32">
                  <c:v>1.373258113861084</c:v>
                </c:pt>
                <c:pt idx="33">
                  <c:v>1.5116766691207886</c:v>
                </c:pt>
                <c:pt idx="34">
                  <c:v>1.6270452737808228</c:v>
                </c:pt>
                <c:pt idx="35">
                  <c:v>1.7234853506088257</c:v>
                </c:pt>
                <c:pt idx="36">
                  <c:v>1.8028405904769897</c:v>
                </c:pt>
                <c:pt idx="37">
                  <c:v>1.8660635948181152</c:v>
                </c:pt>
                <c:pt idx="38">
                  <c:v>1.9173889160156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1E2-684E-B3CE-D87DCAA9D913}"/>
            </c:ext>
          </c:extLst>
        </c:ser>
        <c:ser>
          <c:idx val="1"/>
          <c:order val="1"/>
          <c:tx>
            <c:v>BSA-2</c:v>
          </c:tx>
          <c:spPr>
            <a:ln w="6350">
              <a:solidFill>
                <a:schemeClr val="accent2"/>
              </a:solidFill>
            </a:ln>
          </c:spPr>
          <c:marker>
            <c:symbol val="none"/>
          </c:marker>
          <c:yVal>
            <c:numRef>
              <c:f>Sheet1!$E$9:$E$47</c:f>
              <c:numCache>
                <c:formatCode>General</c:formatCode>
                <c:ptCount val="39"/>
                <c:pt idx="0">
                  <c:v>1.8648597178980708E-3</c:v>
                </c:pt>
                <c:pt idx="1">
                  <c:v>2.0543213468044996E-3</c:v>
                </c:pt>
                <c:pt idx="2">
                  <c:v>2.0341239869594574E-3</c:v>
                </c:pt>
                <c:pt idx="3">
                  <c:v>1.3593778712674975E-3</c:v>
                </c:pt>
                <c:pt idx="4">
                  <c:v>8.2014309009537101E-4</c:v>
                </c:pt>
                <c:pt idx="5">
                  <c:v>4.6186798135749996E-4</c:v>
                </c:pt>
                <c:pt idx="6">
                  <c:v>2.1257993648760021E-4</c:v>
                </c:pt>
                <c:pt idx="7">
                  <c:v>2.2091900973464362E-5</c:v>
                </c:pt>
                <c:pt idx="8">
                  <c:v>-5.4819695651531219E-4</c:v>
                </c:pt>
                <c:pt idx="9">
                  <c:v>-6.1864120652899146E-4</c:v>
                </c:pt>
                <c:pt idx="10">
                  <c:v>-6.9942692061886191E-4</c:v>
                </c:pt>
                <c:pt idx="11">
                  <c:v>-9.9887221585959196E-4</c:v>
                </c:pt>
                <c:pt idx="12">
                  <c:v>-1.0113808093592525E-3</c:v>
                </c:pt>
                <c:pt idx="13">
                  <c:v>-1.2527414364740252E-3</c:v>
                </c:pt>
                <c:pt idx="14">
                  <c:v>-1.600138726644218E-3</c:v>
                </c:pt>
                <c:pt idx="15">
                  <c:v>-1.5189190162345767E-3</c:v>
                </c:pt>
                <c:pt idx="16">
                  <c:v>-1.5894526150077581E-3</c:v>
                </c:pt>
                <c:pt idx="17">
                  <c:v>-1.5837221872061491E-3</c:v>
                </c:pt>
                <c:pt idx="18">
                  <c:v>-1.1420135851949453E-3</c:v>
                </c:pt>
                <c:pt idx="19">
                  <c:v>-2.2272275236900896E-4</c:v>
                </c:pt>
                <c:pt idx="20">
                  <c:v>1.8776936922222376E-3</c:v>
                </c:pt>
                <c:pt idx="21">
                  <c:v>5.9983502142131329E-3</c:v>
                </c:pt>
                <c:pt idx="22">
                  <c:v>1.40887051820755E-2</c:v>
                </c:pt>
                <c:pt idx="23">
                  <c:v>2.9916668310761452E-2</c:v>
                </c:pt>
                <c:pt idx="24">
                  <c:v>6.2443230301141739E-2</c:v>
                </c:pt>
                <c:pt idx="25">
                  <c:v>0.12442491203546524</c:v>
                </c:pt>
                <c:pt idx="26">
                  <c:v>0.23529233038425446</c:v>
                </c:pt>
                <c:pt idx="27">
                  <c:v>0.40498852729797363</c:v>
                </c:pt>
                <c:pt idx="28">
                  <c:v>0.61659115552902222</c:v>
                </c:pt>
                <c:pt idx="29">
                  <c:v>0.84194552898406982</c:v>
                </c:pt>
                <c:pt idx="30">
                  <c:v>1.0568335056304932</c:v>
                </c:pt>
                <c:pt idx="31">
                  <c:v>1.2513316869735718</c:v>
                </c:pt>
                <c:pt idx="32">
                  <c:v>1.4233987331390381</c:v>
                </c:pt>
                <c:pt idx="33">
                  <c:v>1.5704535245895386</c:v>
                </c:pt>
                <c:pt idx="34">
                  <c:v>1.6887814998626709</c:v>
                </c:pt>
                <c:pt idx="35">
                  <c:v>1.7854677438735962</c:v>
                </c:pt>
                <c:pt idx="36">
                  <c:v>1.8615317344665527</c:v>
                </c:pt>
                <c:pt idx="37">
                  <c:v>1.9175564050674438</c:v>
                </c:pt>
                <c:pt idx="38">
                  <c:v>1.96285462379455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1E2-684E-B3CE-D87DCAA9D913}"/>
            </c:ext>
          </c:extLst>
        </c:ser>
        <c:ser>
          <c:idx val="2"/>
          <c:order val="2"/>
          <c:tx>
            <c:v>BSA-3</c:v>
          </c:tx>
          <c:spPr>
            <a:ln w="6350">
              <a:solidFill>
                <a:schemeClr val="accent2"/>
              </a:solidFill>
            </a:ln>
          </c:spPr>
          <c:marker>
            <c:symbol val="none"/>
          </c:marker>
          <c:yVal>
            <c:numRef>
              <c:f>Sheet1!$K$9:$K$47</c:f>
              <c:numCache>
                <c:formatCode>General</c:formatCode>
                <c:ptCount val="39"/>
                <c:pt idx="0">
                  <c:v>3.9133979007601738E-3</c:v>
                </c:pt>
                <c:pt idx="1">
                  <c:v>3.2087643630802631E-3</c:v>
                </c:pt>
                <c:pt idx="2">
                  <c:v>2.19365069642663E-3</c:v>
                </c:pt>
                <c:pt idx="3">
                  <c:v>1.4696458820253611E-3</c:v>
                </c:pt>
                <c:pt idx="4">
                  <c:v>1.0080505162477493E-3</c:v>
                </c:pt>
                <c:pt idx="5">
                  <c:v>3.7622437230311334E-4</c:v>
                </c:pt>
                <c:pt idx="6">
                  <c:v>1.6481954662594944E-4</c:v>
                </c:pt>
                <c:pt idx="7">
                  <c:v>-4.3631024891510606E-4</c:v>
                </c:pt>
                <c:pt idx="8">
                  <c:v>-4.8010679893195629E-4</c:v>
                </c:pt>
                <c:pt idx="9">
                  <c:v>-4.9243209650740027E-4</c:v>
                </c:pt>
                <c:pt idx="10">
                  <c:v>-5.4278515744954348E-4</c:v>
                </c:pt>
                <c:pt idx="11">
                  <c:v>-1.1041287798434496E-3</c:v>
                </c:pt>
                <c:pt idx="12">
                  <c:v>-1.2479419820010662E-3</c:v>
                </c:pt>
                <c:pt idx="13">
                  <c:v>-1.3007387751713395E-3</c:v>
                </c:pt>
                <c:pt idx="14">
                  <c:v>-1.7499065725132823E-3</c:v>
                </c:pt>
                <c:pt idx="15">
                  <c:v>-1.6272870125249028E-3</c:v>
                </c:pt>
                <c:pt idx="16">
                  <c:v>-1.5220122877508402E-3</c:v>
                </c:pt>
                <c:pt idx="17">
                  <c:v>-1.471454743295908E-3</c:v>
                </c:pt>
                <c:pt idx="18">
                  <c:v>-1.0879157343879342E-3</c:v>
                </c:pt>
                <c:pt idx="19">
                  <c:v>-2.0860527001786977E-5</c:v>
                </c:pt>
                <c:pt idx="20">
                  <c:v>1.9609173759818077E-3</c:v>
                </c:pt>
                <c:pt idx="21">
                  <c:v>5.9105725958943367E-3</c:v>
                </c:pt>
                <c:pt idx="22">
                  <c:v>1.4274070970714092E-2</c:v>
                </c:pt>
                <c:pt idx="23">
                  <c:v>3.108968585729599E-2</c:v>
                </c:pt>
                <c:pt idx="24">
                  <c:v>6.3808448612689972E-2</c:v>
                </c:pt>
                <c:pt idx="25">
                  <c:v>0.12697197496891022</c:v>
                </c:pt>
                <c:pt idx="26">
                  <c:v>0.23888981342315674</c:v>
                </c:pt>
                <c:pt idx="27">
                  <c:v>0.4062860906124115</c:v>
                </c:pt>
                <c:pt idx="28">
                  <c:v>0.61297088861465454</c:v>
                </c:pt>
                <c:pt idx="29">
                  <c:v>0.82823145389556885</c:v>
                </c:pt>
                <c:pt idx="30">
                  <c:v>1.0325404405593872</c:v>
                </c:pt>
                <c:pt idx="31">
                  <c:v>1.2178614139556885</c:v>
                </c:pt>
                <c:pt idx="32">
                  <c:v>1.3810348510742188</c:v>
                </c:pt>
                <c:pt idx="33">
                  <c:v>1.5209647417068481</c:v>
                </c:pt>
                <c:pt idx="34">
                  <c:v>1.6382198333740234</c:v>
                </c:pt>
                <c:pt idx="35">
                  <c:v>1.7334146499633789</c:v>
                </c:pt>
                <c:pt idx="36">
                  <c:v>1.8122304677963257</c:v>
                </c:pt>
                <c:pt idx="37">
                  <c:v>1.8733247518539429</c:v>
                </c:pt>
                <c:pt idx="38">
                  <c:v>1.92209446430206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1E2-684E-B3CE-D87DCAA9D913}"/>
            </c:ext>
          </c:extLst>
        </c:ser>
        <c:ser>
          <c:idx val="3"/>
          <c:order val="3"/>
          <c:tx>
            <c:v>BSA+1</c:v>
          </c:tx>
          <c:spPr>
            <a:ln w="6350">
              <a:solidFill>
                <a:schemeClr val="accent1"/>
              </a:solidFill>
            </a:ln>
          </c:spPr>
          <c:marker>
            <c:symbol val="none"/>
          </c:marker>
          <c:yVal>
            <c:numRef>
              <c:f>Sheet1!$E$51:$E$89</c:f>
              <c:numCache>
                <c:formatCode>General</c:formatCode>
                <c:ptCount val="39"/>
                <c:pt idx="0">
                  <c:v>1.7705297796055675E-3</c:v>
                </c:pt>
                <c:pt idx="1">
                  <c:v>9.9147832952439785E-4</c:v>
                </c:pt>
                <c:pt idx="2">
                  <c:v>5.7652185205370188E-4</c:v>
                </c:pt>
                <c:pt idx="3">
                  <c:v>3.6696300958283246E-4</c:v>
                </c:pt>
                <c:pt idx="4">
                  <c:v>4.0312431519851089E-4</c:v>
                </c:pt>
                <c:pt idx="5">
                  <c:v>2.0313200366217643E-4</c:v>
                </c:pt>
                <c:pt idx="6">
                  <c:v>3.5689325886778533E-4</c:v>
                </c:pt>
                <c:pt idx="7">
                  <c:v>1.2125739158364013E-4</c:v>
                </c:pt>
                <c:pt idx="8">
                  <c:v>2.5916381855495274E-4</c:v>
                </c:pt>
                <c:pt idx="9">
                  <c:v>-1.5641847858205438E-4</c:v>
                </c:pt>
                <c:pt idx="10">
                  <c:v>-3.0297521152533591E-4</c:v>
                </c:pt>
                <c:pt idx="11">
                  <c:v>-5.5744615383446217E-4</c:v>
                </c:pt>
                <c:pt idx="12">
                  <c:v>-5.733495345339179E-4</c:v>
                </c:pt>
                <c:pt idx="13">
                  <c:v>-7.9935922985896468E-4</c:v>
                </c:pt>
                <c:pt idx="14">
                  <c:v>-9.088419028557837E-4</c:v>
                </c:pt>
                <c:pt idx="15">
                  <c:v>-1.0230332845821977E-3</c:v>
                </c:pt>
                <c:pt idx="16">
                  <c:v>-8.3520798943936825E-4</c:v>
                </c:pt>
                <c:pt idx="17">
                  <c:v>-5.9648032765835524E-4</c:v>
                </c:pt>
                <c:pt idx="18">
                  <c:v>-4.4158654054626822E-4</c:v>
                </c:pt>
                <c:pt idx="19">
                  <c:v>7.3579506715759635E-4</c:v>
                </c:pt>
                <c:pt idx="20">
                  <c:v>3.1718479003757238E-3</c:v>
                </c:pt>
                <c:pt idx="21">
                  <c:v>8.3804111927747726E-3</c:v>
                </c:pt>
                <c:pt idx="22">
                  <c:v>1.8912056460976601E-2</c:v>
                </c:pt>
                <c:pt idx="23">
                  <c:v>3.9745587855577469E-2</c:v>
                </c:pt>
                <c:pt idx="24">
                  <c:v>7.8855693340301514E-2</c:v>
                </c:pt>
                <c:pt idx="25">
                  <c:v>0.14425735175609589</c:v>
                </c:pt>
                <c:pt idx="26">
                  <c:v>0.23436817526817322</c:v>
                </c:pt>
                <c:pt idx="27">
                  <c:v>0.33244973421096802</c:v>
                </c:pt>
                <c:pt idx="28">
                  <c:v>0.42689156532287598</c:v>
                </c:pt>
                <c:pt idx="29">
                  <c:v>0.51431918144226074</c:v>
                </c:pt>
                <c:pt idx="30">
                  <c:v>0.59600961208343506</c:v>
                </c:pt>
                <c:pt idx="31">
                  <c:v>0.67179667949676514</c:v>
                </c:pt>
                <c:pt idx="32">
                  <c:v>0.74276447296142578</c:v>
                </c:pt>
                <c:pt idx="33">
                  <c:v>0.80860596895217896</c:v>
                </c:pt>
                <c:pt idx="34">
                  <c:v>0.86979764699935913</c:v>
                </c:pt>
                <c:pt idx="35">
                  <c:v>0.92703217267990112</c:v>
                </c:pt>
                <c:pt idx="36">
                  <c:v>0.98041486740112305</c:v>
                </c:pt>
                <c:pt idx="37">
                  <c:v>1.0296519994735718</c:v>
                </c:pt>
                <c:pt idx="38">
                  <c:v>1.07643544673919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61E2-684E-B3CE-D87DCAA9D913}"/>
            </c:ext>
          </c:extLst>
        </c:ser>
        <c:ser>
          <c:idx val="4"/>
          <c:order val="4"/>
          <c:tx>
            <c:v>BSA+2</c:v>
          </c:tx>
          <c:spPr>
            <a:ln w="6350">
              <a:solidFill>
                <a:schemeClr val="accent1"/>
              </a:solidFill>
            </a:ln>
          </c:spPr>
          <c:marker>
            <c:symbol val="none"/>
          </c:marker>
          <c:yVal>
            <c:numRef>
              <c:f>Sheet1!$K$51:$K$89</c:f>
              <c:numCache>
                <c:formatCode>General</c:formatCode>
                <c:ptCount val="39"/>
                <c:pt idx="0">
                  <c:v>1.4576937537640333E-3</c:v>
                </c:pt>
                <c:pt idx="1">
                  <c:v>1.2445407919585705E-3</c:v>
                </c:pt>
                <c:pt idx="2">
                  <c:v>9.4370933948084712E-4</c:v>
                </c:pt>
                <c:pt idx="3">
                  <c:v>3.5293112159706652E-4</c:v>
                </c:pt>
                <c:pt idx="4">
                  <c:v>1.8573329725768417E-4</c:v>
                </c:pt>
                <c:pt idx="5">
                  <c:v>1.5497050480917096E-4</c:v>
                </c:pt>
                <c:pt idx="6">
                  <c:v>5.3577776998281479E-4</c:v>
                </c:pt>
                <c:pt idx="7">
                  <c:v>-6.2898063333705068E-5</c:v>
                </c:pt>
                <c:pt idx="8">
                  <c:v>2.5121160433627665E-4</c:v>
                </c:pt>
                <c:pt idx="9">
                  <c:v>1.2093887198716402E-4</c:v>
                </c:pt>
                <c:pt idx="10">
                  <c:v>-4.401562619023025E-4</c:v>
                </c:pt>
                <c:pt idx="11">
                  <c:v>-4.1053953464142978E-4</c:v>
                </c:pt>
                <c:pt idx="12">
                  <c:v>-1.0359778534621E-3</c:v>
                </c:pt>
                <c:pt idx="13">
                  <c:v>-7.3754420736804605E-4</c:v>
                </c:pt>
                <c:pt idx="14">
                  <c:v>-9.5466093625873327E-4</c:v>
                </c:pt>
                <c:pt idx="15">
                  <c:v>-9.8503625486046076E-4</c:v>
                </c:pt>
                <c:pt idx="16">
                  <c:v>-8.1788183888420463E-4</c:v>
                </c:pt>
                <c:pt idx="17">
                  <c:v>-1.0349985677748919E-3</c:v>
                </c:pt>
                <c:pt idx="18">
                  <c:v>-8.4146909648552537E-4</c:v>
                </c:pt>
                <c:pt idx="19">
                  <c:v>9.4868999440222979E-4</c:v>
                </c:pt>
                <c:pt idx="20">
                  <c:v>3.8272000383585691E-3</c:v>
                </c:pt>
                <c:pt idx="21">
                  <c:v>8.7709818035364151E-3</c:v>
                </c:pt>
                <c:pt idx="22">
                  <c:v>1.8798114731907845E-2</c:v>
                </c:pt>
                <c:pt idx="23">
                  <c:v>4.0709670633077621E-2</c:v>
                </c:pt>
                <c:pt idx="24">
                  <c:v>7.905144989490509E-2</c:v>
                </c:pt>
                <c:pt idx="25">
                  <c:v>0.146152064204216</c:v>
                </c:pt>
                <c:pt idx="26">
                  <c:v>0.23769515752792358</c:v>
                </c:pt>
                <c:pt idx="27">
                  <c:v>0.33657726645469666</c:v>
                </c:pt>
                <c:pt idx="28">
                  <c:v>0.43125057220458984</c:v>
                </c:pt>
                <c:pt idx="29">
                  <c:v>0.52116179466247559</c:v>
                </c:pt>
                <c:pt idx="30">
                  <c:v>0.6047554612159729</c:v>
                </c:pt>
                <c:pt idx="31">
                  <c:v>0.68014425039291382</c:v>
                </c:pt>
                <c:pt idx="32">
                  <c:v>0.75209945440292358</c:v>
                </c:pt>
                <c:pt idx="33">
                  <c:v>0.81848108768463135</c:v>
                </c:pt>
                <c:pt idx="34">
                  <c:v>0.88074743747711182</c:v>
                </c:pt>
                <c:pt idx="35">
                  <c:v>0.93815380334854126</c:v>
                </c:pt>
                <c:pt idx="36">
                  <c:v>0.9918016791343689</c:v>
                </c:pt>
                <c:pt idx="37">
                  <c:v>1.0422403812408447</c:v>
                </c:pt>
                <c:pt idx="38">
                  <c:v>1.08811998367309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61E2-684E-B3CE-D87DCAA9D913}"/>
            </c:ext>
          </c:extLst>
        </c:ser>
        <c:ser>
          <c:idx val="5"/>
          <c:order val="5"/>
          <c:tx>
            <c:v>BSA+3</c:v>
          </c:tx>
          <c:spPr>
            <a:ln w="6350">
              <a:solidFill>
                <a:schemeClr val="accent1"/>
              </a:solidFill>
            </a:ln>
          </c:spPr>
          <c:marker>
            <c:symbol val="none"/>
          </c:marker>
          <c:yVal>
            <c:numRef>
              <c:f>Sheet1!$Q$51:$Q$89</c:f>
              <c:numCache>
                <c:formatCode>General</c:formatCode>
                <c:ptCount val="39"/>
                <c:pt idx="0">
                  <c:v>1.4511329354718328E-3</c:v>
                </c:pt>
                <c:pt idx="1">
                  <c:v>2.4364078126382083E-4</c:v>
                </c:pt>
                <c:pt idx="2">
                  <c:v>2.0732032135128975E-4</c:v>
                </c:pt>
                <c:pt idx="3">
                  <c:v>1.8011938664130867E-4</c:v>
                </c:pt>
                <c:pt idx="4">
                  <c:v>4.6742233098484576E-4</c:v>
                </c:pt>
                <c:pt idx="5">
                  <c:v>4.4916209299117327E-4</c:v>
                </c:pt>
                <c:pt idx="6">
                  <c:v>3.341337142046541E-4</c:v>
                </c:pt>
                <c:pt idx="7">
                  <c:v>1.0496241884538904E-4</c:v>
                </c:pt>
                <c:pt idx="8">
                  <c:v>1.4022714458405972E-4</c:v>
                </c:pt>
                <c:pt idx="9">
                  <c:v>8.2121187006123364E-5</c:v>
                </c:pt>
                <c:pt idx="10">
                  <c:v>-2.6915021589957178E-4</c:v>
                </c:pt>
                <c:pt idx="11">
                  <c:v>-3.5470409784466028E-4</c:v>
                </c:pt>
                <c:pt idx="12">
                  <c:v>-2.4582765763625503E-4</c:v>
                </c:pt>
                <c:pt idx="13">
                  <c:v>-7.6837296364828944E-4</c:v>
                </c:pt>
                <c:pt idx="14">
                  <c:v>-9.2774722725152969E-4</c:v>
                </c:pt>
                <c:pt idx="15">
                  <c:v>-7.7741575660184026E-4</c:v>
                </c:pt>
                <c:pt idx="16">
                  <c:v>-9.9475553724914789E-4</c:v>
                </c:pt>
                <c:pt idx="17">
                  <c:v>-9.1979408171027899E-4</c:v>
                </c:pt>
                <c:pt idx="18">
                  <c:v>-4.5895221410319209E-4</c:v>
                </c:pt>
                <c:pt idx="19">
                  <c:v>7.0051569491624832E-4</c:v>
                </c:pt>
                <c:pt idx="20">
                  <c:v>3.0507354531437159E-3</c:v>
                </c:pt>
                <c:pt idx="21">
                  <c:v>8.4469309076666832E-3</c:v>
                </c:pt>
                <c:pt idx="22">
                  <c:v>1.8666572868824005E-2</c:v>
                </c:pt>
                <c:pt idx="23">
                  <c:v>3.8872137665748596E-2</c:v>
                </c:pt>
                <c:pt idx="24">
                  <c:v>7.7945016324520111E-2</c:v>
                </c:pt>
                <c:pt idx="25">
                  <c:v>0.14514473080635071</c:v>
                </c:pt>
                <c:pt idx="26">
                  <c:v>0.24274002015590668</c:v>
                </c:pt>
                <c:pt idx="27">
                  <c:v>0.35249531269073486</c:v>
                </c:pt>
                <c:pt idx="28">
                  <c:v>0.45898032188415527</c:v>
                </c:pt>
                <c:pt idx="29">
                  <c:v>0.55755990743637085</c:v>
                </c:pt>
                <c:pt idx="30">
                  <c:v>0.6486814022064209</c:v>
                </c:pt>
                <c:pt idx="31">
                  <c:v>0.73235625028610229</c:v>
                </c:pt>
                <c:pt idx="32">
                  <c:v>0.8102995753288269</c:v>
                </c:pt>
                <c:pt idx="33">
                  <c:v>0.88259685039520264</c:v>
                </c:pt>
                <c:pt idx="34">
                  <c:v>0.94955629110336304</c:v>
                </c:pt>
                <c:pt idx="35">
                  <c:v>1.0115724802017212</c:v>
                </c:pt>
                <c:pt idx="36">
                  <c:v>1.0689877271652222</c:v>
                </c:pt>
                <c:pt idx="37">
                  <c:v>1.1221926212310791</c:v>
                </c:pt>
                <c:pt idx="38">
                  <c:v>1.1713843345642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61E2-684E-B3CE-D87DCAA9D9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8180095"/>
        <c:axId val="1"/>
      </c:scatterChart>
      <c:valAx>
        <c:axId val="308180095"/>
        <c:scaling>
          <c:orientation val="minMax"/>
          <c:max val="4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ycle No.</a:t>
                </a:r>
                <a:endParaRPr lang="ja-JP"/>
              </a:p>
            </c:rich>
          </c:tx>
          <c:overlay val="0"/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vert="horz"/>
          <a:lstStyle/>
          <a:p>
            <a:pPr>
              <a:defRPr/>
            </a:pPr>
            <a:endParaRPr lang="ja-JP"/>
          </a:p>
        </c:txPr>
        <c:crossAx val="1"/>
        <c:crossesAt val="1.0000000000000004E-5"/>
        <c:crossBetween val="midCat"/>
      </c:valAx>
      <c:valAx>
        <c:axId val="1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ΔRn</a:t>
                </a:r>
                <a:endParaRPr lang="ja-JP"/>
              </a:p>
            </c:rich>
          </c:tx>
          <c:overlay val="0"/>
        </c:title>
        <c:numFmt formatCode="#,##0.00000_);[Red]\(#,##0.00000\)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308180095"/>
        <c:crosses val="autoZero"/>
        <c:crossBetween val="midCat"/>
      </c:valAx>
      <c:spPr>
        <a:noFill/>
        <a:ln w="25400">
          <a:solidFill>
            <a:schemeClr val="tx1"/>
          </a:solidFill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/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65B3A2-7ECD-7A43-943B-9990D1FCBEC4}" type="datetimeFigureOut">
              <a:t>2026/6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4970E3-B297-0847-97DA-2F4265B0A8FB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76436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CCF93-4297-EE4C-8163-5802CEF2BC2B}" type="datetimeFigureOut">
              <a:t>2026/6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5824D-CED6-5248-8198-AF606FCD0795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1566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CCF93-4297-EE4C-8163-5802CEF2BC2B}" type="datetimeFigureOut">
              <a:t>2026/6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5824D-CED6-5248-8198-AF606FCD0795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068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CCF93-4297-EE4C-8163-5802CEF2BC2B}" type="datetimeFigureOut">
              <a:t>2026/6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5824D-CED6-5248-8198-AF606FCD0795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10346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CCF93-4297-EE4C-8163-5802CEF2BC2B}" type="datetimeFigureOut">
              <a:t>2026/6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5824D-CED6-5248-8198-AF606FCD0795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68958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CCF93-4297-EE4C-8163-5802CEF2BC2B}" type="datetimeFigureOut">
              <a:t>2026/6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5824D-CED6-5248-8198-AF606FCD0795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5797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CCF93-4297-EE4C-8163-5802CEF2BC2B}" type="datetimeFigureOut">
              <a:t>2026/6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5824D-CED6-5248-8198-AF606FCD0795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7743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CCF93-4297-EE4C-8163-5802CEF2BC2B}" type="datetimeFigureOut">
              <a:t>2026/6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5824D-CED6-5248-8198-AF606FCD0795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2132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CCF93-4297-EE4C-8163-5802CEF2BC2B}" type="datetimeFigureOut">
              <a:t>2026/6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5824D-CED6-5248-8198-AF606FCD0795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5157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CCF93-4297-EE4C-8163-5802CEF2BC2B}" type="datetimeFigureOut">
              <a:t>2026/6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5824D-CED6-5248-8198-AF606FCD0795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7862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CCF93-4297-EE4C-8163-5802CEF2BC2B}" type="datetimeFigureOut">
              <a:t>2026/6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5824D-CED6-5248-8198-AF606FCD0795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4742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CCF93-4297-EE4C-8163-5802CEF2BC2B}" type="datetimeFigureOut">
              <a:t>2026/6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5824D-CED6-5248-8198-AF606FCD0795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41063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E9CCF93-4297-EE4C-8163-5802CEF2BC2B}" type="datetimeFigureOut">
              <a:t>2026/6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55824D-CED6-5248-8198-AF606FCD0795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5064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E4D7E68-A9DA-A53B-B12E-A47C62D8F916}"/>
              </a:ext>
            </a:extLst>
          </p:cNvPr>
          <p:cNvSpPr txBox="1"/>
          <p:nvPr/>
        </p:nvSpPr>
        <p:spPr>
          <a:xfrm>
            <a:off x="513471" y="6271030"/>
            <a:ext cx="6114039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Amplification plots from real-time qPCR, showing </a:t>
            </a:r>
            <a:r>
              <a:rPr kumimoji="1" lang="el-GR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 (normalized reporter signal) as a function of cycle number. Orenge lines indicate samples without BSA (</a:t>
            </a:r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3), whereas blue lines indicate samples with BSA (</a:t>
            </a:r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3). Negative </a:t>
            </a:r>
            <a:r>
              <a:rPr kumimoji="1" lang="el-GR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 values are not shown because the y-axis is plotted on a logarithmic scale.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9F002EF1-CEF7-488B-B34B-11371C2D00A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2031834"/>
              </p:ext>
            </p:extLst>
          </p:nvPr>
        </p:nvGraphicFramePr>
        <p:xfrm>
          <a:off x="513471" y="2129812"/>
          <a:ext cx="5420000" cy="38521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708436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</TotalTime>
  <Words>68</Words>
  <Application>Microsoft Macintosh PowerPoint</Application>
  <PresentationFormat>A4 210 x 297 mm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rosoft</dc:creator>
  <cp:lastModifiedBy>Microsoft</cp:lastModifiedBy>
  <cp:revision>25</cp:revision>
  <dcterms:created xsi:type="dcterms:W3CDTF">2026-03-17T10:55:47Z</dcterms:created>
  <dcterms:modified xsi:type="dcterms:W3CDTF">2026-06-28T06:59:47Z</dcterms:modified>
</cp:coreProperties>
</file>